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B51088-CBE7-4260-8EA2-87F8216DFD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2C0B6-AEA1-4B77-9C2F-1A6A7B83AE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A6C1BC-C421-4930-A4C3-33A1861C40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54D4C-F854-464E-A6CC-7141FC4DD6E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D59D4-2972-4729-94B0-45871856AB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1D7B7F-6991-47A4-8EA7-F1804186BC4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471A96-8CB7-4815-802D-CA5A6FB6E0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8B52A-EB83-47D3-8952-7B00B2838E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E7FDB7-B7B6-4B50-AB49-AFCC6D82A8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807487-EE37-4C15-B801-E897620CC6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AA6B3-4D1C-4AFF-AB4E-42B0662FF5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8FC02-C96D-4DC0-97D6-558F66133B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3F46F8-19DA-4D6D-AB8D-80F56D2AC65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54080" y="2317680"/>
            <a:ext cx="1869840" cy="1107720"/>
            <a:chOff x="1054080" y="2317680"/>
            <a:chExt cx="1869840" cy="110772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0" t="0" r="0" b="13232"/>
            <a:stretch/>
          </p:blipFill>
          <p:spPr>
            <a:xfrm>
              <a:off x="1054080" y="2317680"/>
              <a:ext cx="956880" cy="1107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tretch/>
          </p:blipFill>
          <p:spPr>
            <a:xfrm>
              <a:off x="2010960" y="2317680"/>
              <a:ext cx="912960" cy="11055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4" name=""/>
          <p:cNvSpPr/>
          <p:nvPr/>
        </p:nvSpPr>
        <p:spPr>
          <a:xfrm>
            <a:off x="1054080" y="2317680"/>
            <a:ext cx="1870200" cy="1116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4541760" y="2124000"/>
            <a:ext cx="355680" cy="1204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4538520" y="2120760"/>
            <a:ext cx="357480" cy="12034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5429160" y="3297240"/>
            <a:ext cx="352440" cy="316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5425920" y="3292560"/>
            <a:ext cx="354240" cy="31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 flipV="1">
            <a:off x="4714920" y="2019240"/>
            <a:ext cx="1440" cy="101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697280" y="2019240"/>
            <a:ext cx="3816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 flipV="1">
            <a:off x="5602320" y="3278160"/>
            <a:ext cx="1440" cy="144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5583240" y="3278160"/>
            <a:ext cx="3960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4275000" y="1879560"/>
            <a:ext cx="1800" cy="1444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4259160" y="3324240"/>
            <a:ext cx="158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4259160" y="3083040"/>
            <a:ext cx="158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4259160" y="2844720"/>
            <a:ext cx="1584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4259160" y="2603520"/>
            <a:ext cx="158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4259160" y="2359080"/>
            <a:ext cx="1584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4259160" y="2120760"/>
            <a:ext cx="1584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4259160" y="1879560"/>
            <a:ext cx="1584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4275000" y="3324240"/>
            <a:ext cx="177012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4275000" y="3323880"/>
            <a:ext cx="1800" cy="27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 flipV="1">
            <a:off x="5159520" y="3323880"/>
            <a:ext cx="1440" cy="27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 flipV="1">
            <a:off x="6045120" y="3323880"/>
            <a:ext cx="1800" cy="27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4542840" y="1297080"/>
            <a:ext cx="1338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lut4 protein W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4114080" y="32432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4008600" y="30002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008600" y="27622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008600" y="25210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4008600" y="22795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4050360" y="20397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4008600" y="17985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4531680" y="3408480"/>
            <a:ext cx="415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b/o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5379840" y="3395520"/>
            <a:ext cx="450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OKO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 rot="16200000">
            <a:off x="2919240" y="2383920"/>
            <a:ext cx="168012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rbitary units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normalised to ERK1/2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323640" y="1606680"/>
            <a:ext cx="732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lut4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45kDa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323640" y="2362320"/>
            <a:ext cx="732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RK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44kDa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323640" y="2871720"/>
            <a:ext cx="732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RK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42kDa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649440" y="4881600"/>
            <a:ext cx="569592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lut4 protein expression  in white adipose tissue. A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Western blot showing total WAT homogenates (40 µg protein) blotted for GLUT-4, ERK1/2 in ob/ob and POKO mice.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Mean GLUT-4 content of WAT homogenates obtained from densitometric analysis of Western blot autoradiographs shown in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. Units are arbitrary densitometer units. ***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p&lt;0.001 POKO 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vs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ob/ob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576000" y="10573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3498840" y="10717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2255400" y="1239840"/>
            <a:ext cx="450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OKO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1344240" y="1239840"/>
            <a:ext cx="415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b/o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1177920" y="1434960"/>
            <a:ext cx="7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2084400" y="1434960"/>
            <a:ext cx="754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5441400" y="8386920"/>
            <a:ext cx="87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5782320" y="3044880"/>
            <a:ext cx="35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8" name=""/>
          <p:cNvGrpSpPr/>
          <p:nvPr/>
        </p:nvGrpSpPr>
        <p:grpSpPr>
          <a:xfrm>
            <a:off x="1054080" y="1504800"/>
            <a:ext cx="1870200" cy="595080"/>
            <a:chOff x="1054080" y="1504800"/>
            <a:chExt cx="1870200" cy="595080"/>
          </a:xfrm>
        </p:grpSpPr>
        <p:grpSp>
          <p:nvGrpSpPr>
            <p:cNvPr id="89" name=""/>
            <p:cNvGrpSpPr/>
            <p:nvPr/>
          </p:nvGrpSpPr>
          <p:grpSpPr>
            <a:xfrm>
              <a:off x="1054080" y="1504800"/>
              <a:ext cx="1870200" cy="595080"/>
              <a:chOff x="1054080" y="1504800"/>
              <a:chExt cx="1870200" cy="595080"/>
            </a:xfrm>
          </p:grpSpPr>
          <p:grpSp>
            <p:nvGrpSpPr>
              <p:cNvPr id="90" name=""/>
              <p:cNvGrpSpPr/>
              <p:nvPr/>
            </p:nvGrpSpPr>
            <p:grpSpPr>
              <a:xfrm>
                <a:off x="1054080" y="1504800"/>
                <a:ext cx="1869840" cy="580320"/>
                <a:chOff x="1054080" y="1504800"/>
                <a:chExt cx="1869840" cy="580320"/>
              </a:xfrm>
            </p:grpSpPr>
            <p:pic>
              <p:nvPicPr>
                <p:cNvPr id="91" name="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1054080" y="1504800"/>
                  <a:ext cx="972360" cy="580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2" name="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2021400" y="1504800"/>
                  <a:ext cx="902520" cy="57204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93" name=""/>
              <p:cNvSpPr/>
              <p:nvPr/>
            </p:nvSpPr>
            <p:spPr>
              <a:xfrm>
                <a:off x="1054080" y="1504800"/>
                <a:ext cx="1870200" cy="5950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pic>
          <p:nvPicPr>
            <p:cNvPr id="94" name="" descr=""/>
            <p:cNvPicPr/>
            <p:nvPr/>
          </p:nvPicPr>
          <p:blipFill>
            <a:blip r:embed="rId5">
              <a:lum bright="12000"/>
            </a:blip>
            <a:srcRect l="0" t="0" r="1361" b="0"/>
            <a:stretch/>
          </p:blipFill>
          <p:spPr>
            <a:xfrm>
              <a:off x="1060560" y="1511280"/>
              <a:ext cx="954000" cy="5745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2-09T18:50:00Z</dcterms:created>
  <dc:creator>Antonio Vidal-Puig</dc:creator>
  <dc:description/>
  <dc:language>en-US</dc:language>
  <cp:lastModifiedBy>Antonio Vidal-Puig</cp:lastModifiedBy>
  <dcterms:modified xsi:type="dcterms:W3CDTF">2007-03-05T17:31:16Z</dcterms:modified>
  <cp:revision>67</cp:revision>
  <dc:subject/>
  <dc:title>PowerPoint Presentation</dc:title>
</cp:coreProperties>
</file>